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642" y="-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87644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97217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1142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090249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00077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0879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5111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38645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02779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2113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84400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0B9C5-B4D9-4FDA-BA04-30440C7FFB49}" type="datetimeFigureOut">
              <a:rPr lang="nl-BE" smtClean="0"/>
              <a:t>20/09/201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40A30-73D7-4FC2-AFC3-2EA223F22DDF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56520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107504" y="116632"/>
            <a:ext cx="2952328" cy="6624736"/>
            <a:chOff x="548680" y="755576"/>
            <a:chExt cx="2952328" cy="6624736"/>
          </a:xfrm>
        </p:grpSpPr>
        <p:pic>
          <p:nvPicPr>
            <p:cNvPr id="30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89" b="9285"/>
            <a:stretch/>
          </p:blipFill>
          <p:spPr bwMode="auto">
            <a:xfrm>
              <a:off x="850605" y="2871142"/>
              <a:ext cx="2334566" cy="21961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4" b="9636"/>
            <a:stretch/>
          </p:blipFill>
          <p:spPr bwMode="auto">
            <a:xfrm>
              <a:off x="850605" y="755576"/>
              <a:ext cx="2334168" cy="21876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4" b="9639"/>
            <a:stretch/>
          </p:blipFill>
          <p:spPr bwMode="auto">
            <a:xfrm>
              <a:off x="850605" y="4959375"/>
              <a:ext cx="2334169" cy="21875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" name="TextBox 46"/>
            <p:cNvSpPr txBox="1"/>
            <p:nvPr/>
          </p:nvSpPr>
          <p:spPr>
            <a:xfrm rot="16200000">
              <a:off x="-115987" y="1445168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smtClean="0"/>
                <a:t>Nuclei counts</a:t>
              </a:r>
              <a:endParaRPr lang="nl-BE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-129880" y="3533400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smtClean="0"/>
                <a:t>Nuclei counts</a:t>
              </a:r>
              <a:endParaRPr lang="nl-BE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-140912" y="5693640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smtClean="0"/>
                <a:t>Nuclei counts</a:t>
              </a:r>
              <a:endParaRPr lang="nl-BE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340768" y="7103313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smtClean="0"/>
                <a:t>Fluorescence intensity</a:t>
              </a:r>
              <a:endParaRPr lang="nl-BE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51011" y="941403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1</a:t>
              </a:r>
              <a:endParaRPr lang="nl-BE" sz="10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988840" y="3059832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1</a:t>
              </a:r>
              <a:endParaRPr lang="nl-BE" sz="1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906995" y="5220072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1</a:t>
              </a:r>
              <a:endParaRPr lang="nl-BE" sz="1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123019" y="5477906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2</a:t>
              </a:r>
              <a:endParaRPr lang="nl-BE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275419" y="6372200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3</a:t>
              </a:r>
              <a:endParaRPr lang="nl-BE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204864" y="2165539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2</a:t>
              </a:r>
              <a:endParaRPr lang="nl-BE" sz="1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276872" y="4427984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Pp2</a:t>
              </a:r>
              <a:endParaRPr lang="nl-BE" sz="10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411051" y="1043608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1</a:t>
              </a:r>
              <a:endParaRPr lang="nl-BE" sz="10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420888" y="3461683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1</a:t>
              </a:r>
              <a:endParaRPr lang="nl-BE" sz="10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573288" y="5189874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1</a:t>
              </a:r>
              <a:endParaRPr lang="nl-BE" sz="10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627075" y="2309555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2</a:t>
              </a:r>
              <a:endParaRPr lang="nl-BE" sz="10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636912" y="4451482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2</a:t>
              </a:r>
              <a:endParaRPr lang="nl-BE" sz="10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627075" y="6249089"/>
              <a:ext cx="585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000" dirty="0" smtClean="0"/>
                <a:t>Rs2</a:t>
              </a:r>
              <a:endParaRPr lang="nl-BE" sz="10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159189" y="951275"/>
              <a:ext cx="2691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600" dirty="0" smtClean="0"/>
                <a:t>A</a:t>
              </a:r>
              <a:endParaRPr lang="nl-BE" sz="16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172893" y="3136776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600" dirty="0" smtClean="0"/>
                <a:t>B</a:t>
              </a:r>
              <a:endParaRPr lang="nl-BE" sz="16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212976" y="5230736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600" dirty="0" smtClean="0"/>
                <a:t>C</a:t>
              </a:r>
              <a:endParaRPr lang="nl-BE" sz="1600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329533" y="671791"/>
            <a:ext cx="4968552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diploid/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olypl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heterokaryon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howed markedly different histograms compared to those of the diploid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trapl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isolates. In diploid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traploid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the first peak corresponding to the G1 mitotic nuclei, was always the largest peak. The second peak, corresponding to the G2 nuclei (which are the dividing nuclei that contain a doubled DNA content), was always about 10 to 20% of the size of the G1 peak. In the diploid/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olypl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heterokaryon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the relative proportion between the first two peaks was different. The second peak was much larger (sometimes larger than the first peak), and most of the times also a third peak was visible, corresponding to the G2 nuclei of the second population.</a:t>
            </a:r>
            <a:endParaRPr lang="nl-BE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347864" y="302459"/>
            <a:ext cx="32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Supplementary Figure 1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167708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54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en</dc:creator>
  <cp:lastModifiedBy>Lien</cp:lastModifiedBy>
  <cp:revision>6</cp:revision>
  <dcterms:created xsi:type="dcterms:W3CDTF">2013-09-06T12:11:14Z</dcterms:created>
  <dcterms:modified xsi:type="dcterms:W3CDTF">2013-09-20T12:14:55Z</dcterms:modified>
</cp:coreProperties>
</file>